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05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7218B9-791C-4683-94FC-131B31842B4B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90146A-62EC-48BB-BEF1-1A78A50E25C4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6"/>
          <p:cNvSpPr txBox="1">
            <a:spLocks noChangeArrowheads="1"/>
          </p:cNvSpPr>
          <p:nvPr/>
        </p:nvSpPr>
        <p:spPr bwMode="auto">
          <a:xfrm>
            <a:off x="381000" y="381000"/>
            <a:ext cx="2778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>
                <a:latin typeface="Calibri" pitchFamily="34" charset="0"/>
              </a:rPr>
              <a:t>A</a:t>
            </a:r>
          </a:p>
        </p:txBody>
      </p:sp>
      <p:sp>
        <p:nvSpPr>
          <p:cNvPr id="5" name="TextBox 7"/>
          <p:cNvSpPr txBox="1">
            <a:spLocks noChangeArrowheads="1"/>
          </p:cNvSpPr>
          <p:nvPr/>
        </p:nvSpPr>
        <p:spPr bwMode="auto">
          <a:xfrm>
            <a:off x="381000" y="3962400"/>
            <a:ext cx="2714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Calibri" pitchFamily="34" charset="0"/>
              </a:rPr>
              <a:t>B</a:t>
            </a: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52400" y="8077200"/>
            <a:ext cx="6553200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4 Fig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Exon-intron structure and protein domain organization of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FLZ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amily genes from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Physcomitrella patens,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Selaginella moellendorffii, Picea abies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Amborella trichopoda.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 (A) Exon–intron structure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FLZ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 genes and (B) domain organization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of FLZ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 proteins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P. patens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,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S. moellendorffii, P. abies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and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+mn-ea"/>
                <a:cs typeface="Times New Roman" pitchFamily="18" charset="0"/>
              </a:rPr>
              <a:t>A. trichopoda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pic>
        <p:nvPicPr>
          <p:cNvPr id="1027" name="Picture 3" descr="D:\work_Jamsheer\Papers\Phylogentic analysis\PLoSE ONE submission\Minor revision\Amborella gene structure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85800" y="533400"/>
            <a:ext cx="4320000" cy="3412800"/>
          </a:xfrm>
          <a:prstGeom prst="rect">
            <a:avLst/>
          </a:prstGeom>
          <a:noFill/>
        </p:spPr>
      </p:pic>
      <p:pic>
        <p:nvPicPr>
          <p:cNvPr id="2" name="Picture 2" descr="D:\work_Jamsheer\Papers\Phylogentic analysis\PLoSE ONE submission\Minor revision\Amborella PPa Protein (2)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85800" y="4343400"/>
            <a:ext cx="4320000" cy="3412649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A Laxmi-203</dc:creator>
  <cp:lastModifiedBy>Dr.A Laxmi-203</cp:lastModifiedBy>
  <cp:revision>2</cp:revision>
  <dcterms:created xsi:type="dcterms:W3CDTF">2015-07-04T14:59:53Z</dcterms:created>
  <dcterms:modified xsi:type="dcterms:W3CDTF">2015-07-16T11:21:16Z</dcterms:modified>
</cp:coreProperties>
</file>